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3" r:id="rId1"/>
  </p:sldMasterIdLst>
  <p:notesMasterIdLst>
    <p:notesMasterId r:id="rId3"/>
  </p:notesMasterIdLst>
  <p:sldIdLst>
    <p:sldId id="344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80653" autoAdjust="0"/>
  </p:normalViewPr>
  <p:slideViewPr>
    <p:cSldViewPr snapToGrid="0">
      <p:cViewPr varScale="1">
        <p:scale>
          <a:sx n="69" d="100"/>
          <a:sy n="69" d="100"/>
        </p:scale>
        <p:origin x="12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79C713-7A46-4E34-985F-7CB73B996E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30161A-A635-4E62-B378-062580BBF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6190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30161A-A635-4E62-B378-062580BBF63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217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BC6365-0A63-F7BA-3DDE-22F564DC99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680448-4885-18A1-3DF5-8F219C41F5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539B43-3F47-5201-59B7-F77BEF533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3CBD33-4C2E-441B-C896-3655386225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5FC086-E70D-0F8E-7E15-93E1BD730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898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4F176B-5772-8111-2EAE-00EC9A5D6F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793DDC-1EAF-EA69-39C7-DF8C379946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9E2776-C87F-9C99-2A92-450ED3A1E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8B4CA9-0387-D197-D410-514DCE5971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A04584-0C1E-A976-8DED-DE29F723F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854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617CA5-C31D-FFB4-1C8B-B19A038E94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05A880-02DA-E497-5379-4609F61036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603336-1C3B-64D6-D53B-6E80D90A7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05B3B3-E791-841C-AB77-ED6A0076E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089315-70EC-EB05-0C87-436F877B7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289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501F2-0A77-57E7-F0BC-E1917A988A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55D8C5-BF11-67E4-5508-032F7A50FB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879518-3F23-56F2-12A1-A7A4EAC76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A664D9-4B61-E6EB-9532-90758246D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95430C-17FD-9458-9378-4B0ADE9DD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380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78DF5C-49ED-A50E-176F-5FD6C70802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41E628-4247-CCB8-BD10-43B9F93AEC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CC089E-4794-25E9-605C-859AAC01C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EEC35-96CC-AF15-9205-70759FB0C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CF1F17-3BB4-667D-D05E-90D590A90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304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2D88A-4D4D-5196-8DC3-C48C69D110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DBD72B-83C4-11BB-0C59-B007F2C86D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EAB90B-07A9-E42F-FB31-E06318C7B8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BADE5F-DF28-B9CC-8786-9DB13ED0A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632B49-C06F-D3C3-3BB1-C7C71AA885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54EA1B-2E3C-DF71-BB66-69867465E3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403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27F72D-1607-2ACA-B4E6-59715F7947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EAB62D-49AB-38E9-59E1-D14C2064D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53912E-D854-2081-110C-DDE49F6893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A3641A-D0E4-A159-9D04-5EC88541BA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F7A050-519B-9845-2BCD-614528A252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715434-D1EE-6EC0-C7F0-002E02347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1434243-4C43-BD9F-D9A2-6F073BB5A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A02196-01DB-F771-CF60-88FBDC9D2C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421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821E1B-E0D0-80BD-7EDC-73C7BF4182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2A9D42-A690-DD83-6CD4-8833072B0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82D9FD-5536-AA45-98BC-32BBCC411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D83A16-C5CE-4682-73F1-81A833A0E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315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B39253D-F30B-7CCF-9B76-B7CF129DD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27182E-1B5A-CAB7-4C09-52B8190C2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9C8F8A-0B01-FF05-7D9B-6CA49074A7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547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D76BEA-5323-8ADE-3CFB-D764F7AC6E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B174AB-E4EE-3EA1-0214-5CB799FCCF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CD0121-100C-8618-BC89-7E821FEC79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C027D9-C2DF-7A6E-9EA9-AFF6E553D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25F9F3-D000-F45D-B3C3-29B4A7350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B2F92F-0EA7-5820-8263-95BAE12EA7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732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1970DB-5E8A-7B2A-6EAC-A48A7E7BC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40E656-3A0B-D7E5-B88F-4209DED603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731D27-DBE7-CD6B-7505-3BBA9B5554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E357DC-0D4B-5989-F22C-447220C4B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17E7A2-2783-52D2-97AC-CFD4AFA38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2BDF62-A68F-5E70-EA3E-8ECA8BD1A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77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231184A-380D-ED30-68D4-41B0939F6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B73978-8E26-8598-ECA1-41850A5AEA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623254-9E15-7D75-27D8-EB061A3B0D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745B8-CF14-4093-8657-DE7AA740473A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BEEC8C-DD85-21C0-433A-9A8A6B6431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2F9F63-845D-5902-A62A-F6606BC1AE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E55BE-A79D-416E-9E85-E07F9258B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42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4" r:id="rId1"/>
    <p:sldLayoutId id="2147483715" r:id="rId2"/>
    <p:sldLayoutId id="2147483716" r:id="rId3"/>
    <p:sldLayoutId id="2147483717" r:id="rId4"/>
    <p:sldLayoutId id="2147483718" r:id="rId5"/>
    <p:sldLayoutId id="2147483719" r:id="rId6"/>
    <p:sldLayoutId id="2147483720" r:id="rId7"/>
    <p:sldLayoutId id="2147483721" r:id="rId8"/>
    <p:sldLayoutId id="2147483722" r:id="rId9"/>
    <p:sldLayoutId id="2147483723" r:id="rId10"/>
    <p:sldLayoutId id="214748372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D093091-29E4-AC43-A8CA-D6748F13CEAB}"/>
              </a:ext>
            </a:extLst>
          </p:cNvPr>
          <p:cNvSpPr txBox="1"/>
          <p:nvPr/>
        </p:nvSpPr>
        <p:spPr>
          <a:xfrm>
            <a:off x="0" y="0"/>
            <a:ext cx="12192000" cy="5732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marL="0" marR="0" algn="ctr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400" b="1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. Search Strategy performed on </a:t>
            </a:r>
            <a:r>
              <a:rPr lang="en-US" sz="1400" b="1" dirty="0" err="1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oS</a:t>
            </a:r>
            <a:r>
              <a:rPr lang="en-US" sz="1400" b="1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re Collection: SCI-EXPANDED: 1975 to present; Searched September 16, 2022; ESCI: 2017 to present; Searched September 16, 2022. Abbreviations: ESCI, Emerging Sources Citation Index; SCI-EXPANDED, Science Citation Index Expanded; </a:t>
            </a:r>
            <a:r>
              <a:rPr lang="en-US" sz="1400" b="1" dirty="0" err="1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oS</a:t>
            </a:r>
            <a:r>
              <a:rPr lang="en-US" sz="1400" b="1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eb of Science.  </a:t>
            </a:r>
            <a:endParaRPr lang="en-US" sz="600" dirty="0">
              <a:solidFill>
                <a:srgbClr val="0000FF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CE7023A0-757F-C341-4621-086691E8AB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4475753"/>
              </p:ext>
            </p:extLst>
          </p:nvPr>
        </p:nvGraphicFramePr>
        <p:xfrm>
          <a:off x="450111" y="607402"/>
          <a:ext cx="11291778" cy="6135432"/>
        </p:xfrm>
        <a:graphic>
          <a:graphicData uri="http://schemas.openxmlformats.org/drawingml/2006/table">
            <a:tbl>
              <a:tblPr firstRow="1" firstCol="1" bandRow="1"/>
              <a:tblGrid>
                <a:gridCol w="818706">
                  <a:extLst>
                    <a:ext uri="{9D8B030D-6E8A-4147-A177-3AD203B41FA5}">
                      <a16:colId xmlns:a16="http://schemas.microsoft.com/office/drawing/2014/main" val="210218096"/>
                    </a:ext>
                  </a:extLst>
                </a:gridCol>
                <a:gridCol w="9640188">
                  <a:extLst>
                    <a:ext uri="{9D8B030D-6E8A-4147-A177-3AD203B41FA5}">
                      <a16:colId xmlns:a16="http://schemas.microsoft.com/office/drawing/2014/main" val="1943499454"/>
                    </a:ext>
                  </a:extLst>
                </a:gridCol>
                <a:gridCol w="832884">
                  <a:extLst>
                    <a:ext uri="{9D8B030D-6E8A-4147-A177-3AD203B41FA5}">
                      <a16:colId xmlns:a16="http://schemas.microsoft.com/office/drawing/2014/main" val="4075992498"/>
                    </a:ext>
                  </a:extLst>
                </a:gridCol>
              </a:tblGrid>
              <a:tr h="2355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ep</a:t>
                      </a:r>
                      <a:endParaRPr lang="en-US" sz="2000" b="1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arch Details</a:t>
                      </a:r>
                      <a:endParaRPr lang="en-US" sz="2000" b="1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2000" b="1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942010"/>
                  </a:ext>
                </a:extLst>
              </a:tr>
              <a:tr h="196278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S=(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urolog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"nervous system disease*"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zheimer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"amyotrophic lateral sclerosis"  OR  ( brain  NEAR/1  ( damage*  OR  disease*  OR  disorder*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jur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laceration*  OR  trauma*  OR  tumor*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umour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) )  OR  "brain vascular accident*"  OR  "brain vascular disorder*"  OR  "central nervous system disorder*"  OR  ( cerebral  NEAR/1  (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ypox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pals* ) )  OR  ( cerebrovascular  NEAR/1  ( accident*  OR  disease*  OR  disorder*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sufficienc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occlusion* ) )  OR  "CNS disease*"  OR  "CNS disorder*"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cussi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vuls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(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rebr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AND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va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)  OR  dementia  OR  "disseminated sclerosis"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ystoni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"encephalon disease*"  OR  "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ncephalopath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"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pileps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epileptic*  OR  "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uillan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barre"  OR  headache*  OR  head-ache*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miplegi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hemi-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legi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untington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hydrocephalus  OR  "infantile spasm*"  OR  "intracranial vascular disease*"  OR  "intracranial vascular disorder*"  OR  migraine*  OR  "motor neuron disease*"  OR  "movement disorder*"  OR  "multiple sclerosis"  OR  "muscular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ystroph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"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yoclon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neuropath*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inson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seizure*  OR  "spina bifida"  OR  "spinal cord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jur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"  OR  stroke*  OR  (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a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AND  transient )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urette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"transient ischemic attack*"  OR  "transient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schaemic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ttack*"  OR  tremor*  OR  </a:t>
                      </a:r>
                      <a:r>
                        <a:rPr lang="en-US" sz="1100" b="1" i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emour</a:t>
                      </a: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"west syndrome" ) 	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,085,005</a:t>
                      </a:r>
                      <a:endParaRPr lang="en-US" sz="2000" b="1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1513742"/>
                  </a:ext>
                </a:extLst>
              </a:tr>
              <a:tr h="10356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2000" b="1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S=( smartphone*  OR  smart-phone*  OR  cellphone  OR  cell-phone  OR  cell-phones  OR  mobile-based  OR  "mobile tech*"  OR  </a:t>
                      </a:r>
                      <a:r>
                        <a:rPr lang="en-US" sz="11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phone</a:t>
                      </a: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</a:t>
                      </a:r>
                      <a:r>
                        <a:rPr lang="en-US" sz="11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phone*  OR  blackberry*  OR  black-</a:t>
                      </a:r>
                      <a:r>
                        <a:rPr lang="en-US" sz="11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rr</a:t>
                      </a: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  OR  ( ( smart  OR  mobile*  OR  cell  OR  cellular  OR  portable  OR  transportable  OR  trans-portable  OR  wireless  OR  android  OR  apple  OR  google  OR  pixel  OR  </a:t>
                      </a:r>
                      <a:r>
                        <a:rPr lang="en-US" sz="11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uawei</a:t>
                      </a: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OR  </a:t>
                      </a:r>
                      <a:r>
                        <a:rPr lang="en-US" sz="11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novo</a:t>
                      </a: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OR  "LG"  OR  </a:t>
                      </a:r>
                      <a:r>
                        <a:rPr lang="en-US" sz="11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torola</a:t>
                      </a: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OR  </a:t>
                      </a:r>
                      <a:r>
                        <a:rPr lang="en-US" sz="11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kia</a:t>
                      </a: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OR  </a:t>
                      </a:r>
                      <a:r>
                        <a:rPr lang="en-US" sz="11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msung</a:t>
                      </a: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OR  galaxy  OR  </a:t>
                      </a:r>
                      <a:r>
                        <a:rPr lang="en-US" sz="1100" b="1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iaomi</a:t>
                      </a: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)  NEAR/1  ( phone*  OR  telephone*  OR  tele-phone*  OR  handset*  OR  hand-set*  OR  device  OR  devices  OR  device-based  OR  phablet* ) )  OR  ( ( mobile  OR  smartphone*  OR  "smart phone*"  OR  "smart telephone*"  OR  android  OR  apple )  NEAR/2  ( app  OR  application* ) ) 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7,667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2135581"/>
                  </a:ext>
                </a:extLst>
              </a:tr>
              <a:tr h="1306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1 and #2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,393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9484138"/>
                  </a:ext>
                </a:extLst>
              </a:tr>
              <a:tr h="27022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1 and #2 	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ience Citation Index Expanded (SCI-EXPANDED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,991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6166853"/>
                  </a:ext>
                </a:extLst>
              </a:tr>
              <a:tr h="27022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1 AND #2 and English (Languages)	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ience Citation Index Expanded (SCI-EXPANDED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,929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4981172"/>
                  </a:ext>
                </a:extLst>
              </a:tr>
              <a:tr h="45611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1 AND #2 and English (Languages) and Meeting Abstract or Proceeding Paper or Book Chapters or Retracted Publication or News Item or Biographical-Item or Bibliography or Retraction (Exclude – Document Types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ience Citation Index Expanded (SCI-EXPANDED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,545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6644208"/>
                  </a:ext>
                </a:extLst>
              </a:tr>
              <a:tr h="27022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1 AND #2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merging Sources Citation Index (ESCI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4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804883"/>
                  </a:ext>
                </a:extLst>
              </a:tr>
              <a:tr h="27022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1 AND #2 and English (Languages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merging Sources Citation Index (ESCI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7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0897533"/>
                  </a:ext>
                </a:extLst>
              </a:tr>
              <a:tr h="34021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1 AND #2 and English (Languages) and Proceeding Paper (Exclude – Document Types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merging Sources Citation Index (ESCI)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5</a:t>
                      </a:r>
                      <a:endParaRPr lang="en-US" sz="2000" b="1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0760797"/>
                  </a:ext>
                </a:extLst>
              </a:tr>
              <a:tr h="1306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2000" b="1" i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6 OR #9</a:t>
                      </a:r>
                      <a:endParaRPr lang="en-US" sz="2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i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,920</a:t>
                      </a:r>
                      <a:endParaRPr lang="en-US" sz="2000" b="1" i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53496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4857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28</TotalTime>
  <Words>639</Words>
  <Application>Microsoft Office PowerPoint</Application>
  <PresentationFormat>Widescreen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ton, Emily</dc:creator>
  <cp:lastModifiedBy>Acton, Emily</cp:lastModifiedBy>
  <cp:revision>82</cp:revision>
  <dcterms:created xsi:type="dcterms:W3CDTF">2022-10-30T00:23:17Z</dcterms:created>
  <dcterms:modified xsi:type="dcterms:W3CDTF">2023-04-29T05:02:26Z</dcterms:modified>
</cp:coreProperties>
</file>